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2" r:id="rId4"/>
    <p:sldId id="260" r:id="rId5"/>
    <p:sldId id="256" r:id="rId6"/>
    <p:sldId id="257" r:id="rId7"/>
    <p:sldId id="261" r:id="rId8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658E7EC-16DF-46C7-AD15-241A026360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E5846BAC-B6F1-4375-93D7-F2947564AF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06B2BC-A738-4F1F-B847-4260569FE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DA996CA-3210-4E8D-958A-6A9DC8F1B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F0EF281-34F1-4F49-B3A3-75828DAB6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1214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DB308A-8A69-4639-A4B1-9B72419527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D4A2DE8-3A6D-4069-9687-4156B27D63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148FBDE-8024-4E4A-B62D-AC241D755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B06378E-80B0-459C-A903-AC644FAE9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138EE12-59B1-4B03-99E2-1EAE12040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7241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0F72819D-3F12-421C-8097-50167C43A9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1D6510D-D797-4BF9-AC4F-B7F4DE1230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CC75CE-9E4E-42D5-8C99-FBD35914C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CDBA011-AD03-485F-B099-64B88AB97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479FE38-3F00-477A-9B73-C7697EF52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4961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4BCF46-B5C5-4B0D-815E-6807257299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A27538C-170B-47BC-B5AC-4FCDD4C478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A9627B1-86ED-47B2-AA15-8551338C6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F5B00E-EF59-4F36-9B4C-C477F9C0DA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C07AC69-82B4-4306-A93A-3848517D6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550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E5FBAF-B632-4EC2-A91B-D8FB5EEB4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C011F69-C042-40AA-A178-4BEB508B22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11205B6-BE0A-442C-A1BA-1192452EF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C25AE33-DF22-4607-855A-D92F28DBC6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5B9DE10-5B0E-47AF-BE56-8B5B89596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043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B48864-9B7C-4185-9B08-AE2288AB0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ACFA3B0-316A-4DFD-B808-E21130E7B5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40358FE-4A15-4C73-B403-0E213F0A6E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61E171F-1FB3-4E8C-8095-D56A15002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E4A50D0-58FB-42E2-B611-9F2F2A79D2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255C0BF-D697-4AB2-AA83-F89D716045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7752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7F10D2-2065-45FD-A7EB-F003BA7171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A62BEBC-1B93-4330-B5D8-1F12A76111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C2F5008-C1E7-48E4-BCBA-0F427F7AEE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37C84C45-9524-45B1-8A2F-7319BDB713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F06D537-1567-4181-8BD6-EC03F42215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B812391-4846-4619-816E-C2A36DDAF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DD9EAD8B-59AF-42D1-9344-7039B4E4E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B099D04-07CD-4B2F-B4E5-2034555B9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1941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66AAF1-2957-4CB8-A7C1-120EAD0E07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B80AD6AE-E534-49ED-BE37-9F4A5167DE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8B864B1-57DB-4349-B5BC-852D39010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4C9E1E2-0CE0-40CD-B1CF-39F5C963B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1293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8A0D873-A410-4DF1-AF63-CD6C750F9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F93E696-24C5-4C1B-BCBF-61217EC4A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6E7F90D-7787-482E-9FC5-7BF886E12B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3234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5B0D46B-57CA-4C6D-A130-1F55AB255F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6253BD9-273E-436A-BFC5-6A7A9E5EC1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89FECFF-B0D0-4330-9476-5F67B37186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9DFC991-E3B8-4C13-BB54-BC8DF8266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7CF7AFB8-BD94-48F4-A28F-BFDE10FD6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4CA44DB1-B0EB-4D01-8324-08BB6C762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832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7657F10-626B-408B-847A-AE1644BF1E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42D83E7F-9391-4290-BC43-4F02E43ED2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693A1DE-D9E1-44E6-95A5-F9A4A2670E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EC02A21-F3E1-45F0-B44B-1F88BA577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7BCD5F4-4D53-40B9-9EA0-8FEF0E138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C489422-C023-43DA-AF8C-0113CEB65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70939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A8DE84B-13C9-4D87-9E27-5B32B850AF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4DEB0E3-E6AD-43F9-81AC-211DD6ADB8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F465E9-365B-4654-810B-94B20CC8A2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457A10-191D-43B0-8881-D11B2203F67F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F3A39AE-303E-44DC-8556-2B8E611CDE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672897A-CF84-4DE0-926D-251714F8E8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74593-9023-4C70-9C5E-897F2846B0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8787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EDBF4CEF-B6E5-4E2C-B3ED-05568AB7A81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125" t="13611" r="31250" b="7638"/>
          <a:stretch/>
        </p:blipFill>
        <p:spPr>
          <a:xfrm>
            <a:off x="2428875" y="104775"/>
            <a:ext cx="5562600" cy="540067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F3C36FC-88DC-4490-A5FB-FF9266A42A72}"/>
              </a:ext>
            </a:extLst>
          </p:cNvPr>
          <p:cNvSpPr/>
          <p:nvPr/>
        </p:nvSpPr>
        <p:spPr>
          <a:xfrm>
            <a:off x="200024" y="5624036"/>
            <a:ext cx="117062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1: The sunburst plots show the taxonomic classification result. The most accurate taxonomic identification is yellow. </a:t>
            </a:r>
            <a:r>
              <a:rPr lang="fr-FR" dirty="0"/>
              <a:t>Sc 1982-348-25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identified</a:t>
            </a:r>
            <a:r>
              <a:rPr lang="fr-FR" dirty="0"/>
              <a:t> as </a:t>
            </a:r>
            <a:r>
              <a:rPr lang="fr-FR" i="1" dirty="0"/>
              <a:t>Panthera</a:t>
            </a:r>
          </a:p>
        </p:txBody>
      </p:sp>
    </p:spTree>
    <p:extLst>
      <p:ext uri="{BB962C8B-B14F-4D97-AF65-F5344CB8AC3E}">
        <p14:creationId xmlns:p14="http://schemas.microsoft.com/office/powerpoint/2010/main" val="4002076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6D2EB431-BB75-4094-974F-94F8DE316A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969" t="15000" r="30859" b="7361"/>
          <a:stretch/>
        </p:blipFill>
        <p:spPr>
          <a:xfrm>
            <a:off x="2913017" y="295003"/>
            <a:ext cx="5629275" cy="532447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02B1E963-2473-4B17-8E5C-FCF413E4814D}"/>
              </a:ext>
            </a:extLst>
          </p:cNvPr>
          <p:cNvSpPr/>
          <p:nvPr/>
        </p:nvSpPr>
        <p:spPr>
          <a:xfrm>
            <a:off x="0" y="5934670"/>
            <a:ext cx="120586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2: The sunburst plots show the taxonomic classification result. The most accurate taxonomic identification is yellow. </a:t>
            </a:r>
            <a:r>
              <a:rPr lang="fr-FR" dirty="0"/>
              <a:t>Sc 1983-338-17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identified</a:t>
            </a:r>
            <a:r>
              <a:rPr lang="fr-FR" dirty="0"/>
              <a:t> as </a:t>
            </a:r>
            <a:r>
              <a:rPr lang="fr-FR" i="1" dirty="0"/>
              <a:t>Panthera</a:t>
            </a:r>
          </a:p>
        </p:txBody>
      </p:sp>
    </p:spTree>
    <p:extLst>
      <p:ext uri="{BB962C8B-B14F-4D97-AF65-F5344CB8AC3E}">
        <p14:creationId xmlns:p14="http://schemas.microsoft.com/office/powerpoint/2010/main" val="30645108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7AC0A93F-44AF-4724-B5A8-BEDE8E7759A6}"/>
              </a:ext>
            </a:extLst>
          </p:cNvPr>
          <p:cNvSpPr/>
          <p:nvPr/>
        </p:nvSpPr>
        <p:spPr>
          <a:xfrm>
            <a:off x="0" y="5934670"/>
            <a:ext cx="120586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3: The sunburst plots show the taxonomic classification result. The most accurate taxonomic identification is yellow. </a:t>
            </a:r>
            <a:r>
              <a:rPr lang="fr-FR" dirty="0"/>
              <a:t>Sc 1986-1278-160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identified</a:t>
            </a:r>
            <a:r>
              <a:rPr lang="fr-FR" dirty="0"/>
              <a:t> as </a:t>
            </a:r>
            <a:r>
              <a:rPr lang="fr-FR" i="1" dirty="0"/>
              <a:t>Panthera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F83BCC7A-8DF2-4539-9E12-D7BD8CD278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929" t="13460" r="31000" b="6920"/>
          <a:stretch/>
        </p:blipFill>
        <p:spPr>
          <a:xfrm>
            <a:off x="2368731" y="165462"/>
            <a:ext cx="5617030" cy="5460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135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FC18DBA-2D63-4213-B926-853357899B96}"/>
              </a:ext>
            </a:extLst>
          </p:cNvPr>
          <p:cNvSpPr/>
          <p:nvPr/>
        </p:nvSpPr>
        <p:spPr>
          <a:xfrm>
            <a:off x="341638" y="301109"/>
            <a:ext cx="18694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Sc1986-1270-302 </a:t>
            </a:r>
            <a:endParaRPr lang="fr-FR" dirty="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BFA40FFA-2C55-4E81-8E32-5533723DB5FD}"/>
              </a:ext>
            </a:extLst>
          </p:cNvPr>
          <p:cNvSpPr/>
          <p:nvPr/>
        </p:nvSpPr>
        <p:spPr>
          <a:xfrm>
            <a:off x="0" y="5934670"/>
            <a:ext cx="120586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4: The sunburst plots show the taxonomic classification result. The most accurate taxonomic identification is yellow. </a:t>
            </a:r>
            <a:r>
              <a:rPr lang="fr-FR" dirty="0"/>
              <a:t>Sc 1986-1270-302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identified</a:t>
            </a:r>
            <a:r>
              <a:rPr lang="fr-FR" dirty="0"/>
              <a:t> as </a:t>
            </a:r>
            <a:r>
              <a:rPr lang="fr-FR" i="1" dirty="0"/>
              <a:t>Panthera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8A9C6DE3-E126-4ED9-988B-902D8F156E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71" t="14222" r="31500" b="6667"/>
          <a:stretch/>
        </p:blipFill>
        <p:spPr>
          <a:xfrm>
            <a:off x="2847703" y="383177"/>
            <a:ext cx="5599611" cy="5425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29513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4C8609C8-59E6-416B-B2B5-9A732DD0A198}"/>
              </a:ext>
            </a:extLst>
          </p:cNvPr>
          <p:cNvSpPr/>
          <p:nvPr/>
        </p:nvSpPr>
        <p:spPr>
          <a:xfrm>
            <a:off x="6096000" y="1329232"/>
            <a:ext cx="6096000" cy="1477328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Figure S5: Sequence alignment of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Bos </a:t>
            </a:r>
            <a:r>
              <a:rPr lang="en-US" i="1" kern="100" dirty="0" err="1">
                <a:latin typeface="Calibri" panose="020F0502020204030204" pitchFamily="34" charset="0"/>
                <a:ea typeface="Calibri" panose="020F0502020204030204" pitchFamily="34" charset="0"/>
              </a:rPr>
              <a:t>taurus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Bison </a:t>
            </a:r>
            <a:r>
              <a:rPr lang="en-US" i="1" kern="100" dirty="0" err="1">
                <a:latin typeface="Calibri" panose="020F0502020204030204" pitchFamily="34" charset="0"/>
                <a:ea typeface="Calibri" panose="020F0502020204030204" pitchFamily="34" charset="0"/>
              </a:rPr>
              <a:t>bison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 for COL3A1 proteins with Align tools from </a:t>
            </a:r>
            <a:r>
              <a:rPr lang="en-US" kern="100" dirty="0" err="1">
                <a:latin typeface="Calibri" panose="020F0502020204030204" pitchFamily="34" charset="0"/>
                <a:ea typeface="Calibri" panose="020F0502020204030204" pitchFamily="34" charset="0"/>
              </a:rPr>
              <a:t>Uniprot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 (P04258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Bos </a:t>
            </a:r>
            <a:r>
              <a:rPr lang="en-US" i="1" kern="100" dirty="0" err="1">
                <a:latin typeface="Calibri" panose="020F0502020204030204" pitchFamily="34" charset="0"/>
                <a:ea typeface="Calibri" panose="020F0502020204030204" pitchFamily="34" charset="0"/>
              </a:rPr>
              <a:t>taurus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, A0A6P3J3V1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Bison bison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). The SAPs are indicate with yellow star. The alignment was realize with Muscle Multiple Sequence Alignment (MSA).</a:t>
            </a:r>
            <a:endParaRPr lang="fr-FR" dirty="0"/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DA1DF918-E2E2-4325-A0DB-D896C47743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826" y="0"/>
            <a:ext cx="5953490" cy="6858000"/>
          </a:xfrm>
          <a:prstGeom prst="rect">
            <a:avLst/>
          </a:prstGeom>
        </p:spPr>
      </p:pic>
      <p:sp>
        <p:nvSpPr>
          <p:cNvPr id="14" name="Étoile : 5 branches 13">
            <a:extLst>
              <a:ext uri="{FF2B5EF4-FFF2-40B4-BE49-F238E27FC236}">
                <a16:creationId xmlns:a16="http://schemas.microsoft.com/office/drawing/2014/main" id="{6262FC8E-6B39-449B-8498-CE5944073514}"/>
              </a:ext>
            </a:extLst>
          </p:cNvPr>
          <p:cNvSpPr/>
          <p:nvPr/>
        </p:nvSpPr>
        <p:spPr>
          <a:xfrm>
            <a:off x="5156563" y="755469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Étoile : 5 branches 15">
            <a:extLst>
              <a:ext uri="{FF2B5EF4-FFF2-40B4-BE49-F238E27FC236}">
                <a16:creationId xmlns:a16="http://schemas.microsoft.com/office/drawing/2014/main" id="{93E664DE-F327-484F-B083-1547B2360A65}"/>
              </a:ext>
            </a:extLst>
          </p:cNvPr>
          <p:cNvSpPr/>
          <p:nvPr/>
        </p:nvSpPr>
        <p:spPr>
          <a:xfrm>
            <a:off x="2382883" y="1407931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Étoile : 5 branches 16">
            <a:extLst>
              <a:ext uri="{FF2B5EF4-FFF2-40B4-BE49-F238E27FC236}">
                <a16:creationId xmlns:a16="http://schemas.microsoft.com/office/drawing/2014/main" id="{1DA919A0-CB09-4E91-9FA5-51FF7CC09BD3}"/>
              </a:ext>
            </a:extLst>
          </p:cNvPr>
          <p:cNvSpPr/>
          <p:nvPr/>
        </p:nvSpPr>
        <p:spPr>
          <a:xfrm>
            <a:off x="3973558" y="1422219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" name="Étoile : 5 branches 17">
            <a:extLst>
              <a:ext uri="{FF2B5EF4-FFF2-40B4-BE49-F238E27FC236}">
                <a16:creationId xmlns:a16="http://schemas.microsoft.com/office/drawing/2014/main" id="{A047D2C6-6B43-48A2-B0A0-A8DC8B3E3718}"/>
              </a:ext>
            </a:extLst>
          </p:cNvPr>
          <p:cNvSpPr/>
          <p:nvPr/>
        </p:nvSpPr>
        <p:spPr>
          <a:xfrm>
            <a:off x="4616495" y="1407931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" name="Étoile : 5 branches 18">
            <a:extLst>
              <a:ext uri="{FF2B5EF4-FFF2-40B4-BE49-F238E27FC236}">
                <a16:creationId xmlns:a16="http://schemas.microsoft.com/office/drawing/2014/main" id="{5CDF66FE-20FA-40F4-B50C-2ADA247C418E}"/>
              </a:ext>
            </a:extLst>
          </p:cNvPr>
          <p:cNvSpPr/>
          <p:nvPr/>
        </p:nvSpPr>
        <p:spPr>
          <a:xfrm>
            <a:off x="4349796" y="2489019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Étoile : 5 branches 19">
            <a:extLst>
              <a:ext uri="{FF2B5EF4-FFF2-40B4-BE49-F238E27FC236}">
                <a16:creationId xmlns:a16="http://schemas.microsoft.com/office/drawing/2014/main" id="{DBC1D605-AB09-43CF-BA6E-F004642CE434}"/>
              </a:ext>
            </a:extLst>
          </p:cNvPr>
          <p:cNvSpPr/>
          <p:nvPr/>
        </p:nvSpPr>
        <p:spPr>
          <a:xfrm>
            <a:off x="5249909" y="2493781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Étoile : 5 branches 20">
            <a:extLst>
              <a:ext uri="{FF2B5EF4-FFF2-40B4-BE49-F238E27FC236}">
                <a16:creationId xmlns:a16="http://schemas.microsoft.com/office/drawing/2014/main" id="{19C4F912-A6DF-43A7-9517-23C8EDD8968D}"/>
              </a:ext>
            </a:extLst>
          </p:cNvPr>
          <p:cNvSpPr/>
          <p:nvPr/>
        </p:nvSpPr>
        <p:spPr>
          <a:xfrm>
            <a:off x="5335634" y="3193869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Étoile : 5 branches 21">
            <a:extLst>
              <a:ext uri="{FF2B5EF4-FFF2-40B4-BE49-F238E27FC236}">
                <a16:creationId xmlns:a16="http://schemas.microsoft.com/office/drawing/2014/main" id="{1E9B95E9-BD14-4D2B-B7D2-32509CBA99F9}"/>
              </a:ext>
            </a:extLst>
          </p:cNvPr>
          <p:cNvSpPr/>
          <p:nvPr/>
        </p:nvSpPr>
        <p:spPr>
          <a:xfrm>
            <a:off x="3244896" y="4989331"/>
            <a:ext cx="72000" cy="72000"/>
          </a:xfrm>
          <a:prstGeom prst="star5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283203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 9">
            <a:extLst>
              <a:ext uri="{FF2B5EF4-FFF2-40B4-BE49-F238E27FC236}">
                <a16:creationId xmlns:a16="http://schemas.microsoft.com/office/drawing/2014/main" id="{CED63498-4DBA-4EE8-BEBD-B73A64CA68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29442"/>
            <a:ext cx="7762875" cy="4074437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F5DCF389-1D28-4236-96DD-5E6608F07467}"/>
              </a:ext>
            </a:extLst>
          </p:cNvPr>
          <p:cNvSpPr/>
          <p:nvPr/>
        </p:nvSpPr>
        <p:spPr>
          <a:xfrm>
            <a:off x="415290" y="4373017"/>
            <a:ext cx="954786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Figure S6: MS/MS spectra of COL3A1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Bos </a:t>
            </a:r>
            <a:r>
              <a:rPr lang="en-US" i="1" kern="100" dirty="0" err="1">
                <a:latin typeface="Calibri" panose="020F0502020204030204" pitchFamily="34" charset="0"/>
                <a:ea typeface="Calibri" panose="020F0502020204030204" pitchFamily="34" charset="0"/>
              </a:rPr>
              <a:t>taurus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peptide sequence GEPGAPGLK from sample 1983-382-120. The peptide mass is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m/z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 413.7009 with </a:t>
            </a:r>
            <a:r>
              <a:rPr lang="en-US" i="1" kern="100" dirty="0">
                <a:latin typeface="Calibri" panose="020F0502020204030204" pitchFamily="34" charset="0"/>
                <a:ea typeface="Calibri" panose="020F0502020204030204" pitchFamily="34" charset="0"/>
              </a:rPr>
              <a:t>z</a:t>
            </a:r>
            <a:r>
              <a:rPr lang="en-US" kern="100" dirty="0">
                <a:latin typeface="Calibri" panose="020F0502020204030204" pitchFamily="34" charset="0"/>
                <a:ea typeface="Calibri" panose="020F0502020204030204" pitchFamily="34" charset="0"/>
              </a:rPr>
              <a:t> =2. The table shows the masses of the fragments identified (blue for b ions and red for y ions).</a:t>
            </a:r>
            <a:endParaRPr lang="fr-FR" dirty="0"/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id="{450A5CDA-515E-4CCD-B503-30B6C4E5ED4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859" t="67500" r="51641" b="16250"/>
          <a:stretch/>
        </p:blipFill>
        <p:spPr>
          <a:xfrm>
            <a:off x="7353300" y="1057275"/>
            <a:ext cx="4355774" cy="144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98915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E4870A26-F134-445F-9095-566C5EC0D8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656" t="16250" r="30859" b="5694"/>
          <a:stretch/>
        </p:blipFill>
        <p:spPr>
          <a:xfrm>
            <a:off x="733425" y="504824"/>
            <a:ext cx="5667375" cy="5353051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BADC901-F465-4295-AA69-061E66061E9A}"/>
              </a:ext>
            </a:extLst>
          </p:cNvPr>
          <p:cNvSpPr/>
          <p:nvPr/>
        </p:nvSpPr>
        <p:spPr>
          <a:xfrm>
            <a:off x="0" y="5934670"/>
            <a:ext cx="1205865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Figure S7: The sunburst plots show the taxonomic classification result. The most accurate taxonomic identification is yellow. </a:t>
            </a:r>
            <a:r>
              <a:rPr lang="fr-FR" dirty="0"/>
              <a:t>Sc </a:t>
            </a:r>
            <a:r>
              <a:rPr lang="fr-FR" dirty="0" err="1"/>
              <a:t>Sc</a:t>
            </a:r>
            <a:r>
              <a:rPr lang="fr-FR" dirty="0"/>
              <a:t> 1983-382-120  </a:t>
            </a:r>
            <a:r>
              <a:rPr lang="fr-FR" dirty="0" err="1"/>
              <a:t>is</a:t>
            </a:r>
            <a:r>
              <a:rPr lang="fr-FR" dirty="0"/>
              <a:t> </a:t>
            </a:r>
            <a:r>
              <a:rPr lang="fr-FR" dirty="0" err="1"/>
              <a:t>identified</a:t>
            </a:r>
            <a:r>
              <a:rPr lang="fr-FR" dirty="0"/>
              <a:t> as </a:t>
            </a:r>
            <a:r>
              <a:rPr lang="fr-FR" i="1" dirty="0"/>
              <a:t>Bos </a:t>
            </a:r>
            <a:r>
              <a:rPr lang="fr-FR" i="1" dirty="0" err="1"/>
              <a:t>sp</a:t>
            </a:r>
            <a:r>
              <a:rPr lang="fr-FR" i="1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51791651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233</Words>
  <Application>Microsoft Office PowerPoint</Application>
  <PresentationFormat>Grand écran</PresentationFormat>
  <Paragraphs>8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rice Bray</dc:creator>
  <cp:lastModifiedBy>Fabrice Bray</cp:lastModifiedBy>
  <cp:revision>10</cp:revision>
  <dcterms:created xsi:type="dcterms:W3CDTF">2025-04-14T09:02:04Z</dcterms:created>
  <dcterms:modified xsi:type="dcterms:W3CDTF">2025-04-23T09:35:38Z</dcterms:modified>
</cp:coreProperties>
</file>